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3.xml.rels" ContentType="application/vnd.openxmlformats-package.relationships+xml"/>
  <Override PartName="/ppt/notesSlides/_rels/notesSlide2.xml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it-IT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43080" y="685440"/>
            <a:ext cx="257184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it-IT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0EAF757D-7989-4E66-A383-F3A6E63840BC}" type="slidenum">
              <a:rPr b="0" lang="it-IT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59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it-IT" sz="1200" spc="-1" strike="noStrike">
              <a:solidFill>
                <a:srgbClr val="000000"/>
              </a:solidFill>
              <a:latin typeface="Calibri"/>
              <a:ea typeface="MS PGothic"/>
            </a:endParaRPr>
          </a:p>
        </p:txBody>
      </p:sp>
      <p:sp>
        <p:nvSpPr>
          <p:cNvPr id="60" name="Segnaposto numero diapositiva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0A70CADD-4A9A-4349-A371-E23839C6BAF6}" type="slidenum">
              <a:rPr b="0" lang="it-IT" sz="1200" spc="-1" strike="noStrike">
                <a:solidFill>
                  <a:srgbClr val="000000"/>
                </a:solidFill>
                <a:latin typeface="Calibri"/>
                <a:ea typeface="MS PGothic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62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it-IT" sz="1200" spc="-1" strike="noStrike">
              <a:solidFill>
                <a:srgbClr val="000000"/>
              </a:solidFill>
              <a:latin typeface="Calibri"/>
              <a:ea typeface="MS PGothic"/>
            </a:endParaRPr>
          </a:p>
        </p:txBody>
      </p:sp>
      <p:sp>
        <p:nvSpPr>
          <p:cNvPr id="63" name="Segnaposto numero diapositiva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B6FFDDB3-1BDF-4595-81E6-6ACA1A11ADB4}" type="slidenum">
              <a:rPr b="0" lang="it-IT" sz="1200" spc="-1" strike="noStrike">
                <a:solidFill>
                  <a:srgbClr val="000000"/>
                </a:solidFill>
                <a:latin typeface="Calibri"/>
                <a:ea typeface="MS PGothic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65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it-IT" sz="1200" spc="-1" strike="noStrike">
              <a:solidFill>
                <a:srgbClr val="000000"/>
              </a:solidFill>
              <a:latin typeface="Calibri"/>
              <a:ea typeface="MS PGothic"/>
            </a:endParaRPr>
          </a:p>
        </p:txBody>
      </p:sp>
      <p:sp>
        <p:nvSpPr>
          <p:cNvPr id="66" name="Segnaposto numero diapositiva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A4570D34-580A-4B42-A268-BDE4D4ECF7CA}" type="slidenum">
              <a:rPr b="0" lang="it-IT" sz="1200" spc="-1" strike="noStrike">
                <a:solidFill>
                  <a:srgbClr val="000000"/>
                </a:solidFill>
                <a:latin typeface="Calibri"/>
                <a:ea typeface="MS PGothic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4D9698-C068-47B1-B21E-5DCB488F119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494406-486E-4A91-AF7B-F3D2B4423BB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A4856C-DB92-43F2-A504-28EBF01DD6F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8EF682-C76D-4789-9755-2F8C5EC4EE8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2D14E7-5775-4840-B2DC-876E44EC1C1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E3984D-4600-498C-90D7-72913800AB2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BFE9D3-70AD-4EA7-8C58-38E5AEDB47A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368FF1-B79F-4DA3-97CA-62776DDF7FF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910C46-E9C5-48CB-9A6B-C90705392F6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E6F29C-3369-4DE5-AC81-9CEA1DA2345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6E53DE-665B-4F55-B03A-ACAB068FC13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14AABF-DB04-4E47-BB32-4AF956ED8D7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E10B3636-9759-4F85-945B-4B43E3F1D43B}" type="slidenum">
              <a:rPr b="0" lang="it-IT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CasellaDiTesto 3"/>
          <p:cNvSpPr/>
          <p:nvPr/>
        </p:nvSpPr>
        <p:spPr>
          <a:xfrm>
            <a:off x="158760" y="4638600"/>
            <a:ext cx="5014800" cy="244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0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r>
              <a:rPr b="0" lang="it-I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For PC3, DU145, LNCaP and 22RV1 information has been derived from www.sanger.ac.uk.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Rettangolo 8"/>
          <p:cNvSpPr/>
          <p:nvPr/>
        </p:nvSpPr>
        <p:spPr>
          <a:xfrm>
            <a:off x="-27000" y="5937120"/>
            <a:ext cx="6567480" cy="846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bbreviations: VPA: Valproic Acid; SIM: Simvastatin; DTX: Docetaxel; IC: Inhibitory Concentration; mut: mutation; wt: wild type. The IC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50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values were computed at 96h of treatment (mean ± s.d. from at least three separate experiments performed in triplicates). Cell growth assessment was done by sulforhodamine B colorimetric assay (see Materials and Methods).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50" name=""/>
          <p:cNvGraphicFramePr/>
          <p:nvPr/>
        </p:nvGraphicFramePr>
        <p:xfrm>
          <a:off x="27000" y="1116000"/>
          <a:ext cx="6858000" cy="4619520"/>
        </p:xfrm>
        <a:graphic>
          <a:graphicData uri="http://schemas.openxmlformats.org/drawingml/2006/table">
            <a:tbl>
              <a:tblPr/>
              <a:tblGrid>
                <a:gridCol w="652320"/>
                <a:gridCol w="900360"/>
                <a:gridCol w="601560"/>
                <a:gridCol w="600120"/>
                <a:gridCol w="1401840"/>
                <a:gridCol w="900000"/>
                <a:gridCol w="901800"/>
                <a:gridCol w="900000"/>
              </a:tblGrid>
              <a:tr h="808560">
                <a:tc>
                  <a:txBody>
                    <a:bodyPr lIns="39600" rIns="39600" tIns="6120" bIns="0" anchor="ctr" anchorCtr="1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Cell line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0" marR="39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39600" rIns="39600" tIns="6120" bIns="0" anchor="ctr" anchorCtr="1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Origi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0" marR="39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39600" rIns="39600" tIns="6120" bIns="0" anchor="ctr" anchorCtr="1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p5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0" marR="39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39600" rIns="39600" tIns="6120" bIns="0" anchor="ctr" anchorCtr="1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RA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0" marR="39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39600" rIns="39600" tIns="6120" bIns="0" anchor="ctr" anchorCtr="1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a </a:t>
                      </a: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Additional feature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0" marR="39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39600" rIns="39600" tIns="612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VP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IC</a:t>
                      </a:r>
                      <a:r>
                        <a:rPr b="1" lang="en-GB" sz="10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5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</a:t>
                      </a: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(</a:t>
                      </a:r>
                      <a:r>
                        <a:rPr b="1" lang="it-IT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m</a:t>
                      </a: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M )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96h ± D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0" marR="39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tIns="42120" bIns="42120" anchor="ctr" anchorCtr="1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SI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</a:t>
                      </a: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IC</a:t>
                      </a:r>
                      <a:r>
                        <a:rPr b="1" lang="en-GB" sz="10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5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(</a:t>
                      </a:r>
                      <a:r>
                        <a:rPr b="1" lang="it-IT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µ</a:t>
                      </a: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M ) 96h ± D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tIns="42120" bIns="42120" anchor="ctr" anchorCtr="1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DTX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IC</a:t>
                      </a:r>
                      <a:r>
                        <a:rPr b="1" lang="en-GB" sz="10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5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(</a:t>
                      </a:r>
                      <a:r>
                        <a:rPr b="1" lang="it-IT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n</a:t>
                      </a: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M ) 96h ± D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</a:tr>
              <a:tr h="501840">
                <a:tc>
                  <a:txBody>
                    <a:bodyPr lIns="39600" rIns="39600" tIns="6120" bIns="0" anchor="ctr" anchorCtr="1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PC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0" marR="39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600" rIns="39600" tIns="6120" bIns="0" anchor="ctr" anchorCtr="1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PC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0" marR="39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600" rIns="39600" tIns="6120" bIns="0" anchor="ctr" anchorCtr="1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null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0" marR="39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600" rIns="39600" tIns="6120" bIns="0" anchor="ctr" anchorCtr="1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w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0" marR="39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600" rIns="39600" tIns="6120" bIns="0" anchor="ctr" anchorCtr="1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AR-null; androgen ind.; PTEN-null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0" marR="39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600" rIns="39600" tIns="612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 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1.9  ±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0.6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0" marR="39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tIns="42120" bIns="4212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 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2.5 ±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0.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tIns="42120" bIns="4212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0.27±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0.1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876960">
                <a:tc>
                  <a:txBody>
                    <a:bodyPr lIns="39600" rIns="39600" tIns="6120" bIns="0" anchor="ctr" anchorCtr="1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DU14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0" marR="39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600" rIns="39600" tIns="6120" bIns="0" anchor="ctr" anchorCtr="1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PC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0" marR="39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600" rIns="39600" tIns="6120" bIns="0" anchor="ctr" anchorCtr="1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mu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P274L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V223F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0" marR="39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600" rIns="39600" tIns="6120" bIns="0" anchor="ctr" anchorCtr="1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wt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0" marR="39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600" rIns="39600" tIns="6120" bIns="0" anchor="ctr" anchorCtr="1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AR+; androgen ind; PTEN–Wt; CDKN2A -mut; MLH1-mut; RB1-mut; STK11-null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0" marR="39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600" rIns="39600" tIns="612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2.5 ±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0.5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0" marR="39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tIns="42120" bIns="4212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1.37 ± 0.3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tIns="42120" bIns="4212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 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0.32 ± 0.0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831240">
                <a:tc>
                  <a:txBody>
                    <a:bodyPr lIns="39600" rIns="39600" tIns="6120" bIns="0" anchor="ctr" anchorCtr="1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DU14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R8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0" marR="39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600" rIns="39600" tIns="6120" bIns="0" anchor="ctr" anchorCtr="1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PC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0" marR="39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600" rIns="39600" tIns="6120" bIns="0" anchor="ctr" anchorCtr="1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mu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P274L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V223F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0" marR="39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600" rIns="39600" tIns="6120" bIns="0" anchor="ctr" anchorCtr="1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w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0" marR="39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600" rIns="39600" tIns="6120" bIns="0" anchor="ctr" anchorCtr="1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DU145 derive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SIM-resistant cell lin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0" marR="39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600" rIns="39600" tIns="612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 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0.84 ±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0.1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0" marR="39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tIns="42120" bIns="4212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 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17.5 ±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3.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tIns="42120" bIns="4212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 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0.19 ± 0.0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536760">
                <a:tc>
                  <a:txBody>
                    <a:bodyPr lIns="39600" rIns="39600" tIns="6120" bIns="0" anchor="ctr" anchorCtr="1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LNCaP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0" marR="39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600" rIns="39600" tIns="6120" bIns="0" anchor="ctr" anchorCtr="1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PC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0" marR="39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600" rIns="39600" tIns="6120" bIns="0" anchor="ctr" anchorCtr="1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w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0" marR="39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600" rIns="39600" tIns="6120" bIns="0" anchor="ctr" anchorCtr="1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w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0" marR="39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600" rIns="39600" tIns="6120" bIns="0" anchor="ctr" anchorCtr="1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AR+; androgen dep.; PTEN-mut;  JAK1-mu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0" marR="39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600" rIns="39600" tIns="612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5 ±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  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0.8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0" marR="39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600" rIns="39600" tIns="6120" bIns="0" anchor="ctr" anchorCtr="1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4.9 ±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0.9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0" marR="39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600" rIns="39600" tIns="6120" bIns="0" anchor="ctr" anchorCtr="1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1.1±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0.0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0" marR="39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528480">
                <a:tc>
                  <a:txBody>
                    <a:bodyPr lIns="39600" rIns="39600" tIns="6120" bIns="0" anchor="ctr" anchorCtr="1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22Rv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0" marR="39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600" rIns="39600" tIns="6120" bIns="0" anchor="ctr" anchorCtr="1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PC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0" marR="39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600" rIns="39600" tIns="6120" bIns="0" anchor="ctr" anchorCtr="1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mu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Q331R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0" marR="39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600" rIns="39600" tIns="6120" bIns="0" anchor="ctr" anchorCtr="1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w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0" marR="39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360" rIns="9360" tIns="86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AR mut; androgen dependent; N-RAS mu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600" rIns="39600" tIns="6120" bIns="0" anchor="ctr" anchorCtr="1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 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1.82 ±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0.13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0" marR="39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600" rIns="39600" tIns="6120" bIns="0" anchor="ctr" anchorCtr="1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 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4.96 ±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1.03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0" marR="39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600" rIns="39600" tIns="6120" bIns="0" anchor="ctr" anchorCtr="1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  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0.92 ±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0.19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0" marR="39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535680">
                <a:tc>
                  <a:txBody>
                    <a:bodyPr lIns="39600" rIns="39600" tIns="6120" bIns="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EP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0" marR="39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600" rIns="39600" tIns="6120" bIns="0" anchor="ctr" anchorCtr="1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Epithelial Normal Prostat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0" marR="39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600" rIns="39600" tIns="6120" bIns="0" anchor="ctr" anchorCtr="1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-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0" marR="39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600" rIns="39600" tIns="6120" bIns="0" anchor="ctr" anchorCtr="1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-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0" marR="39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600" rIns="39600" tIns="6120" bIns="0" anchor="ctr" anchorCtr="1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-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0" marR="39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600" rIns="39600" tIns="6120" bIns="0" anchor="ctr" anchorCtr="1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 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1.42 ±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0.5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0" marR="39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600" rIns="39600" tIns="6120" bIns="0" anchor="ctr" anchorCtr="1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 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1.41 ±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0.6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0" marR="39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9600" rIns="39600" tIns="6120" bIns="0" anchor="ctr" anchorCtr="1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  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0.88 ±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0.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9600" marR="39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51" name="CasellaDiTesto 6"/>
          <p:cNvSpPr/>
          <p:nvPr/>
        </p:nvSpPr>
        <p:spPr>
          <a:xfrm>
            <a:off x="1440" y="317520"/>
            <a:ext cx="6856560" cy="320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50120" rIns="150120" tIns="75240" bIns="75240" anchor="t">
            <a:spAutoFit/>
          </a:bodyPr>
          <a:p>
            <a:pPr>
              <a:lnSpc>
                <a:spcPct val="93000"/>
              </a:lnSpc>
              <a:spcBef>
                <a:spcPts val="300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Times New Roman"/>
                <a:ea typeface="MS PGothic"/>
              </a:rPr>
              <a:t>Supplementary Table S1. Screening of  PCa cell lines, antiproliferative effect of drugs alone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CasellaDiTesto 6"/>
          <p:cNvSpPr/>
          <p:nvPr/>
        </p:nvSpPr>
        <p:spPr>
          <a:xfrm>
            <a:off x="-7920" y="252360"/>
            <a:ext cx="6856560" cy="48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50120" rIns="150120" tIns="75240" bIns="75240" anchor="t">
            <a:spAutoFit/>
          </a:bodyPr>
          <a:p>
            <a:pPr algn="just">
              <a:lnSpc>
                <a:spcPct val="93000"/>
              </a:lnSpc>
              <a:spcBef>
                <a:spcPts val="300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Times New Roman"/>
                <a:ea typeface="MS PGothic"/>
              </a:rPr>
              <a:t>Supplementary Table S2.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MS PGothic"/>
              </a:rPr>
              <a:t>Antiproliferative effect induced by VPA in combination with SIM on PCa cell line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Rettangolo 9"/>
          <p:cNvSpPr/>
          <p:nvPr/>
        </p:nvSpPr>
        <p:spPr>
          <a:xfrm>
            <a:off x="85680" y="3973680"/>
            <a:ext cx="6570720" cy="1434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07280" rIns="107280" tIns="53640" bIns="5364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ifferent cytotoxic ratios (50:50, 75:25 and 25:75) of each of the two agents were evaluated after 96h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I values (mean ±S.D.) from at least three separate experiments performed in quadruplicate) computed at 50% of cell kill (CI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50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 by CalcuSyn software (Biosoft,Cam- bridge, UK); CIs values &lt;0.8 indicate strong synergism; CIs &lt;0.9 sinergysm; C</a:t>
            </a:r>
            <a:r>
              <a:rPr b="0" lang="it-IT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 between 0.9 and 1.2 additivity; CI&gt; 1.2 antagonism;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c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RI values (mean ±S.D.) from at least three separate experiments performed in quadruplicate) represent the order of magnitude (fold) of dose reduction obtained for IC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50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(DRI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50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 in combination setting compared with each drug alone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54" name=""/>
          <p:cNvGraphicFramePr/>
          <p:nvPr/>
        </p:nvGraphicFramePr>
        <p:xfrm>
          <a:off x="236520" y="717480"/>
          <a:ext cx="6572160" cy="3198960"/>
        </p:xfrm>
        <a:graphic>
          <a:graphicData uri="http://schemas.openxmlformats.org/drawingml/2006/table">
            <a:tbl>
              <a:tblPr/>
              <a:tblGrid>
                <a:gridCol w="623880"/>
                <a:gridCol w="1749600"/>
                <a:gridCol w="2232000"/>
                <a:gridCol w="1966680"/>
              </a:tblGrid>
              <a:tr h="199080">
                <a:tc>
                  <a:txBody>
                    <a:bodyPr lIns="23040" rIns="23040" tIns="648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3040" marR="23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gridSpan="3">
                  <a:txBody>
                    <a:bodyPr lIns="23040" rIns="23040" tIns="648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VPA/SIM cytotoxix ratio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3040" marR="23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315720"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</a:t>
                      </a:r>
                      <a:r>
                        <a:rPr b="1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Cell Lin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50:50</a:t>
                      </a:r>
                      <a:r>
                        <a:rPr b="0" lang="en-US" sz="9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75:2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25:7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37120">
                <a:tc>
                  <a:txBody>
                    <a:bodyPr lIns="23040" rIns="23040" tIns="648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PC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3040" marR="23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</a:t>
                      </a:r>
                      <a:r>
                        <a:rPr b="0" lang="it-IT" sz="9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b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CI</a:t>
                      </a:r>
                      <a:r>
                        <a:rPr b="0" lang="it-IT" sz="9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50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:</a:t>
                      </a:r>
                      <a:r>
                        <a:rPr b="0" lang="it-IT" sz="9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0.70 ±0.0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</a:t>
                      </a:r>
                      <a:r>
                        <a:rPr b="0" lang="it-IT" sz="9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c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DRI</a:t>
                      </a:r>
                      <a:r>
                        <a:rPr b="0" lang="it-IT" sz="9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50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VPA : 2.49 ±0.1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 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DRI</a:t>
                      </a:r>
                      <a:r>
                        <a:rPr b="0" lang="it-IT" sz="9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50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SIM  :  3.45 ±0.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9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CI</a:t>
                      </a:r>
                      <a:r>
                        <a:rPr b="0" lang="it-IT" sz="9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50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:</a:t>
                      </a:r>
                      <a:r>
                        <a:rPr b="0" lang="it-IT" sz="9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0.84 ±0.1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DRI</a:t>
                      </a:r>
                      <a:r>
                        <a:rPr b="0" lang="it-IT" sz="9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50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VPA : 1.3 ±0.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DRI</a:t>
                      </a:r>
                      <a:r>
                        <a:rPr b="0" lang="it-IT" sz="9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50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SIM  :  14.6 ±4.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9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CI</a:t>
                      </a:r>
                      <a:r>
                        <a:rPr b="0" lang="it-IT" sz="9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50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:</a:t>
                      </a:r>
                      <a:r>
                        <a:rPr b="0" lang="it-IT" sz="9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0.84 ±0.0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DRI</a:t>
                      </a:r>
                      <a:r>
                        <a:rPr b="0" lang="it-IT" sz="9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50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VPA : 15.1 ±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DRI</a:t>
                      </a:r>
                      <a:r>
                        <a:rPr b="0" lang="it-IT" sz="9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50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SIM  :  1.3 ±0.1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</a:tr>
              <a:tr h="537120">
                <a:tc>
                  <a:txBody>
                    <a:bodyPr lIns="23040" rIns="23040" tIns="648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DU14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3040" marR="23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CI</a:t>
                      </a:r>
                      <a:r>
                        <a:rPr b="0" lang="it-IT" sz="9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50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:</a:t>
                      </a:r>
                      <a:r>
                        <a:rPr b="0" lang="it-IT" sz="9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0.57 ±0.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DRI</a:t>
                      </a:r>
                      <a:r>
                        <a:rPr b="0" lang="it-IT" sz="9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50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VPA : 4.05 ±0.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DRI</a:t>
                      </a:r>
                      <a:r>
                        <a:rPr b="0" lang="it-IT" sz="9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50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SIM  : 2.9 ±0.3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9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CI</a:t>
                      </a:r>
                      <a:r>
                        <a:rPr b="0" lang="it-IT" sz="9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50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:</a:t>
                      </a:r>
                      <a:r>
                        <a:rPr b="0" lang="it-IT" sz="9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0.73 ±0.0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DRI</a:t>
                      </a:r>
                      <a:r>
                        <a:rPr b="0" lang="it-IT" sz="9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50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VPA : 1.5 ±0.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DRI</a:t>
                      </a:r>
                      <a:r>
                        <a:rPr b="0" lang="it-IT" sz="9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50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SIM  : 9.5 ±1.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9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CI</a:t>
                      </a:r>
                      <a:r>
                        <a:rPr b="0" lang="it-IT" sz="9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50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:</a:t>
                      </a:r>
                      <a:r>
                        <a:rPr b="0" lang="it-IT" sz="9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0.19 ±0.0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DRI</a:t>
                      </a:r>
                      <a:r>
                        <a:rPr b="0" lang="it-IT" sz="9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50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VPA : 117 ±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DRI</a:t>
                      </a:r>
                      <a:r>
                        <a:rPr b="0" lang="it-IT" sz="9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50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SIM  : 5.4 ±1.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37120">
                <a:tc>
                  <a:txBody>
                    <a:bodyPr lIns="23040" rIns="23040" tIns="648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DUR8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3040" marR="23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</a:t>
                      </a:r>
                      <a:r>
                        <a:rPr b="0" lang="it-IT" sz="9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CI</a:t>
                      </a:r>
                      <a:r>
                        <a:rPr b="0" lang="it-IT" sz="9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50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:</a:t>
                      </a:r>
                      <a:r>
                        <a:rPr b="0" lang="it-IT" sz="9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0.68 ±0.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DRI</a:t>
                      </a:r>
                      <a:r>
                        <a:rPr b="0" lang="it-IT" sz="9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50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VPA : 1.4 ±0.2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DRI</a:t>
                      </a:r>
                      <a:r>
                        <a:rPr b="0" lang="it-IT" sz="9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50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SIM  :  17.9 ±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9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CI</a:t>
                      </a:r>
                      <a:r>
                        <a:rPr b="0" lang="it-IT" sz="9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50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:</a:t>
                      </a:r>
                      <a:r>
                        <a:rPr b="0" lang="it-IT" sz="9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0.45 ±0.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DRI</a:t>
                      </a:r>
                      <a:r>
                        <a:rPr b="0" lang="it-IT" sz="9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50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VPA : 2.2 ±0.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DRI</a:t>
                      </a:r>
                      <a:r>
                        <a:rPr b="0" lang="it-IT" sz="9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50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SIM  :  268 ±13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9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CI</a:t>
                      </a:r>
                      <a:r>
                        <a:rPr b="0" lang="it-IT" sz="9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50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:</a:t>
                      </a:r>
                      <a:r>
                        <a:rPr b="0" lang="it-IT" sz="9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0.81 ±0.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DRI</a:t>
                      </a:r>
                      <a:r>
                        <a:rPr b="0" lang="it-IT" sz="9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50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VPA : 2.7 ±0.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DRI</a:t>
                      </a:r>
                      <a:r>
                        <a:rPr b="0" lang="it-IT" sz="9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50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SIM  : 2.4 ±0.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</a:tr>
              <a:tr h="537120">
                <a:tc>
                  <a:txBody>
                    <a:bodyPr lIns="23040" rIns="23040" tIns="648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LNCAP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3040" marR="23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9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CI</a:t>
                      </a:r>
                      <a:r>
                        <a:rPr b="0" lang="it-IT" sz="9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50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:</a:t>
                      </a:r>
                      <a:r>
                        <a:rPr b="0" lang="it-IT" sz="9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1,19 ±0,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DRI</a:t>
                      </a:r>
                      <a:r>
                        <a:rPr b="0" lang="it-IT" sz="9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50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VPA : 1.48 ±0.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DRI</a:t>
                      </a:r>
                      <a:r>
                        <a:rPr b="0" lang="it-IT" sz="9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50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SIM  :  2.81 ±0.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9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CI</a:t>
                      </a:r>
                      <a:r>
                        <a:rPr b="0" lang="it-IT" sz="9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50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:</a:t>
                      </a:r>
                      <a:r>
                        <a:rPr b="0" lang="it-IT" sz="9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0.67 ±0,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DRI</a:t>
                      </a:r>
                      <a:r>
                        <a:rPr b="0" lang="it-IT" sz="9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50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VPA : 1.7 ±0.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DRI</a:t>
                      </a:r>
                      <a:r>
                        <a:rPr b="0" lang="it-IT" sz="9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50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SIM  :  26.9 ±3.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9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CI</a:t>
                      </a:r>
                      <a:r>
                        <a:rPr b="0" lang="it-IT" sz="9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50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:</a:t>
                      </a:r>
                      <a:r>
                        <a:rPr b="0" lang="it-IT" sz="9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1.9 ±0.5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DRI</a:t>
                      </a:r>
                      <a:r>
                        <a:rPr b="0" lang="it-IT" sz="9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50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VPA : 2.5 ±0.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DRI</a:t>
                      </a:r>
                      <a:r>
                        <a:rPr b="0" lang="it-IT" sz="9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50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SIM  :  0.7 ±0.2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37120">
                <a:tc>
                  <a:txBody>
                    <a:bodyPr lIns="23040" rIns="23040" tIns="648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22Rv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3040" marR="23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9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CI</a:t>
                      </a:r>
                      <a:r>
                        <a:rPr b="0" lang="it-IT" sz="9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50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:</a:t>
                      </a:r>
                      <a:r>
                        <a:rPr b="0" lang="it-IT" sz="9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0,57 ±0.1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DRI</a:t>
                      </a:r>
                      <a:r>
                        <a:rPr b="0" lang="it-IT" sz="9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50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VPA : 2.89 ±0.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DRI</a:t>
                      </a:r>
                      <a:r>
                        <a:rPr b="0" lang="it-IT" sz="9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50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SIM  :  4.6 ±1.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9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CI</a:t>
                      </a:r>
                      <a:r>
                        <a:rPr b="0" lang="it-IT" sz="9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50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:</a:t>
                      </a:r>
                      <a:r>
                        <a:rPr b="0" lang="it-IT" sz="9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0.84 ±0.3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DRI</a:t>
                      </a:r>
                      <a:r>
                        <a:rPr b="0" lang="it-IT" sz="9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50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VPA : 1.3±0.5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DRI</a:t>
                      </a:r>
                      <a:r>
                        <a:rPr b="0" lang="it-IT" sz="9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50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SIM  :  18.2 ±8.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9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CI</a:t>
                      </a:r>
                      <a:r>
                        <a:rPr b="0" lang="it-IT" sz="9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50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:</a:t>
                      </a:r>
                      <a:r>
                        <a:rPr b="0" lang="it-IT" sz="9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0.48 ±0.0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DRI</a:t>
                      </a:r>
                      <a:r>
                        <a:rPr b="0" lang="it-IT" sz="9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50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VPA : 22.5 ±2.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DRI</a:t>
                      </a:r>
                      <a:r>
                        <a:rPr b="0" lang="it-IT" sz="9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50</a:t>
                      </a:r>
                      <a:r>
                        <a:rPr b="0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SIM  :  2.2 ±0.3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CasellaDiTesto 10"/>
          <p:cNvSpPr/>
          <p:nvPr/>
        </p:nvSpPr>
        <p:spPr>
          <a:xfrm>
            <a:off x="0" y="192240"/>
            <a:ext cx="6856560" cy="48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50120" rIns="150120" tIns="75240" bIns="75240" anchor="t">
            <a:spAutoFit/>
          </a:bodyPr>
          <a:p>
            <a:pPr algn="just">
              <a:lnSpc>
                <a:spcPct val="93000"/>
              </a:lnSpc>
              <a:spcBef>
                <a:spcPts val="300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Times New Roman"/>
                <a:ea typeface="MS PGothic"/>
              </a:rPr>
              <a:t>Supplementary Table S3. Antiproliferative effect induced by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MS PGothic"/>
              </a:rPr>
              <a:t>by VPA in combination with SIM </a:t>
            </a:r>
            <a:r>
              <a:rPr b="1" lang="it-IT" sz="1200" spc="-1" strike="noStrike">
                <a:solidFill>
                  <a:srgbClr val="000000"/>
                </a:solidFill>
                <a:latin typeface="Times New Roman"/>
                <a:ea typeface="MS PGothic"/>
              </a:rPr>
              <a:t>accordingly to different  schedules of exposure  in PC3 and 22Rv1 cell  line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Rettangolo 9"/>
          <p:cNvSpPr/>
          <p:nvPr/>
        </p:nvSpPr>
        <p:spPr>
          <a:xfrm>
            <a:off x="152280" y="2689200"/>
            <a:ext cx="6570720" cy="1617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07280" rIns="107280" tIns="53640" bIns="5364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r>
              <a:rPr b="0" lang="it-IT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quipotent doses (50:50 cytotoxic ratio) of each of the two agents were evaluated after 96h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ither simultaneously or sequentially (24h delay between the two agents)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I values (mean ±S.D.) from at least three separate experiments performed in quadruplicate) computed at 50% of cell kill (CI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50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 by CalcuSyn software (Biosoft,Cam- bridge, UK); CIs values &lt;0.8 indicate strong synergism; CIs &lt;0.9 sinergysm; C</a:t>
            </a:r>
            <a:r>
              <a:rPr b="0" lang="it-IT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 between 0.9 and 1.2 additivity; CI&gt; 1.2 antagonism;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c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RI values (mean ±S.D.) from at least three separate experiments performed in quadruplicate) represent the order of magnitude (fold) of dose reduction obtained for IC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50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(DRI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50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 in combination setting compared with each drug alone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57" name=""/>
          <p:cNvGraphicFramePr/>
          <p:nvPr/>
        </p:nvGraphicFramePr>
        <p:xfrm>
          <a:off x="42840" y="785880"/>
          <a:ext cx="6773760" cy="1873080"/>
        </p:xfrm>
        <a:graphic>
          <a:graphicData uri="http://schemas.openxmlformats.org/drawingml/2006/table">
            <a:tbl>
              <a:tblPr/>
              <a:tblGrid>
                <a:gridCol w="1149480"/>
                <a:gridCol w="1720800"/>
                <a:gridCol w="1950840"/>
                <a:gridCol w="1952640"/>
              </a:tblGrid>
              <a:tr h="525240"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Cell Line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VPA+SIM</a:t>
                      </a:r>
                      <a:r>
                        <a:rPr b="0" lang="en-US" sz="9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VPA→SIM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SIM→ VP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54120">
                <a:tc>
                  <a:txBody>
                    <a:bodyPr lIns="23040" rIns="23040" tIns="612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PC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3040" marR="23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</a:t>
                      </a:r>
                      <a:r>
                        <a:rPr b="0" lang="en-US" sz="8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b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C</a:t>
                      </a: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I</a:t>
                      </a:r>
                      <a:r>
                        <a:rPr b="0" lang="it-IT" sz="8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50</a:t>
                      </a: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:</a:t>
                      </a:r>
                      <a:r>
                        <a:rPr b="0" lang="it-IT" sz="8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</a:t>
                      </a: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0.8±0.0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 </a:t>
                      </a:r>
                      <a:r>
                        <a:rPr b="0" lang="en-US" sz="8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c 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DRI </a:t>
                      </a: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: VPA:3.4±0.7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</a:t>
                      </a: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DRI</a:t>
                      </a:r>
                      <a:r>
                        <a:rPr b="0" lang="it-IT" sz="8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50</a:t>
                      </a: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SIM: 2.46±0.5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</a:t>
                      </a: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CI</a:t>
                      </a:r>
                      <a:r>
                        <a:rPr b="0" lang="it-IT" sz="8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50</a:t>
                      </a: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:</a:t>
                      </a:r>
                      <a:r>
                        <a:rPr b="0" lang="it-IT" sz="8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</a:t>
                      </a: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0.67±0.1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</a:t>
                      </a: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DRI</a:t>
                      </a:r>
                      <a:r>
                        <a:rPr b="0" lang="it-IT" sz="8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50</a:t>
                      </a: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VPA:2.59±0.6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</a:t>
                      </a: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DRI</a:t>
                      </a:r>
                      <a:r>
                        <a:rPr b="0" lang="it-IT" sz="8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50</a:t>
                      </a: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SIM:3.79±0.9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</a:t>
                      </a: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CI</a:t>
                      </a:r>
                      <a:r>
                        <a:rPr b="0" lang="it-IT" sz="8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50</a:t>
                      </a: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:</a:t>
                      </a:r>
                      <a:r>
                        <a:rPr b="0" lang="it-IT" sz="8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</a:t>
                      </a: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0.86 ±0.1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</a:t>
                      </a: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DRI</a:t>
                      </a:r>
                      <a:r>
                        <a:rPr b="0" lang="it-IT" sz="8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50</a:t>
                      </a: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VPA: 3.67±0.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</a:t>
                      </a: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DRI</a:t>
                      </a:r>
                      <a:r>
                        <a:rPr b="0" lang="it-IT" sz="8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50</a:t>
                      </a: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SIM: 1.52±0.8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2f2f2"/>
                    </a:solidFill>
                  </a:tcPr>
                </a:tc>
              </a:tr>
              <a:tr h="693720">
                <a:tc>
                  <a:txBody>
                    <a:bodyPr lIns="23040" rIns="23040" tIns="612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9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22Rv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3040" marR="230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</a:t>
                      </a: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CI</a:t>
                      </a:r>
                      <a:r>
                        <a:rPr b="0" lang="it-IT" sz="8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50</a:t>
                      </a: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:0.6±0.1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</a:t>
                      </a: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DRI</a:t>
                      </a:r>
                      <a:r>
                        <a:rPr b="0" lang="it-IT" sz="8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50</a:t>
                      </a: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VPA: 2.9±0.6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</a:t>
                      </a: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DRI</a:t>
                      </a:r>
                      <a:r>
                        <a:rPr b="0" lang="it-IT" sz="8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50</a:t>
                      </a: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SIM:4.02±1.4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</a:t>
                      </a: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CI</a:t>
                      </a:r>
                      <a:r>
                        <a:rPr b="0" lang="it-IT" sz="8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50</a:t>
                      </a: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:</a:t>
                      </a:r>
                      <a:r>
                        <a:rPr b="0" lang="it-IT" sz="8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</a:t>
                      </a: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0.63±0.0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</a:t>
                      </a: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DRI</a:t>
                      </a:r>
                      <a:r>
                        <a:rPr b="0" lang="it-IT" sz="8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50</a:t>
                      </a: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VPA:2.09±0.3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</a:t>
                      </a: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DRI</a:t>
                      </a:r>
                      <a:r>
                        <a:rPr b="0" lang="it-IT" sz="8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50</a:t>
                      </a: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SIM:6.56±0.0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</a:t>
                      </a: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CI</a:t>
                      </a:r>
                      <a:r>
                        <a:rPr b="0" lang="it-IT" sz="8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50</a:t>
                      </a: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:</a:t>
                      </a:r>
                      <a:r>
                        <a:rPr b="0" lang="it-IT" sz="8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</a:t>
                      </a: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0.65±0.0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</a:t>
                      </a: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DRI</a:t>
                      </a:r>
                      <a:r>
                        <a:rPr b="0" lang="it-IT" sz="8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50</a:t>
                      </a: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VPA : 3.41±0.7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</a:t>
                      </a: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DRI</a:t>
                      </a:r>
                      <a:r>
                        <a:rPr b="0" lang="it-IT" sz="8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50</a:t>
                      </a:r>
                      <a:r>
                        <a:rPr b="0" lang="it-IT" sz="800" spc="-1" strike="noStrike">
                          <a:solidFill>
                            <a:srgbClr val="000000"/>
                          </a:solidFill>
                          <a:latin typeface="Times New Roman"/>
                          <a:ea typeface="MS PGothic"/>
                        </a:rPr>
                        <a:t> SIM  : 2.97±0.9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0-07-28T15:30:09Z</dcterms:created>
  <dc:creator>Alfredo Budillon</dc:creator>
  <dc:description/>
  <dc:language>en-US</dc:language>
  <cp:lastModifiedBy>Alfredo Budillon</cp:lastModifiedBy>
  <dcterms:modified xsi:type="dcterms:W3CDTF">2020-07-28T15:31:12Z</dcterms:modified>
  <cp:revision>1</cp:revision>
  <dc:subject/>
  <dc:title>Presentazione di PowerPoint</dc:title>
</cp:coreProperties>
</file>